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4324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834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4782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245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5738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7037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108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4070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412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4559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8255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6106C-63B4-43FF-9BDC-5DB268884D00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A0195-1F6B-4FEB-AF4A-91653B5E4C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5380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16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2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24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64" t="32592" r="21759" b="64084"/>
          <a:stretch/>
        </p:blipFill>
        <p:spPr>
          <a:xfrm>
            <a:off x="3000142" y="2425512"/>
            <a:ext cx="2160000" cy="1140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77" t="31855" r="21346" b="63528"/>
          <a:stretch/>
        </p:blipFill>
        <p:spPr>
          <a:xfrm>
            <a:off x="3000142" y="2268870"/>
            <a:ext cx="2160000" cy="158358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1475757"/>
              </p:ext>
            </p:extLst>
          </p:nvPr>
        </p:nvGraphicFramePr>
        <p:xfrm>
          <a:off x="3000142" y="1578134"/>
          <a:ext cx="2160002" cy="683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6154">
                  <a:extLst>
                    <a:ext uri="{9D8B030D-6E8A-4147-A177-3AD203B41FA5}">
                      <a16:colId xmlns:a16="http://schemas.microsoft.com/office/drawing/2014/main" val="1848485906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2677818888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3146015335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2126965722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2669136215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3647131408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141552620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3260762399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2726284612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2599857253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1192897036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3599808452"/>
                    </a:ext>
                  </a:extLst>
                </a:gridCol>
                <a:gridCol w="166154">
                  <a:extLst>
                    <a:ext uri="{9D8B030D-6E8A-4147-A177-3AD203B41FA5}">
                      <a16:colId xmlns:a16="http://schemas.microsoft.com/office/drawing/2014/main" val="1939417053"/>
                    </a:ext>
                  </a:extLst>
                </a:gridCol>
              </a:tblGrid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275720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840941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2039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7767824"/>
                  </a:ext>
                </a:extLst>
              </a:tr>
            </a:tbl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5113066" y="1742935"/>
            <a:ext cx="6944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[1 h]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5113066" y="1912275"/>
            <a:ext cx="93807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[1 h]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5113066" y="2086587"/>
            <a:ext cx="9364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60" t="46630" r="23965" b="49492"/>
          <a:stretch/>
        </p:blipFill>
        <p:spPr>
          <a:xfrm>
            <a:off x="3000142" y="2552621"/>
            <a:ext cx="2160000" cy="13302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1" name="Gerade Verbindung mit Pfeil 10"/>
          <p:cNvCxnSpPr/>
          <p:nvPr/>
        </p:nvCxnSpPr>
        <p:spPr>
          <a:xfrm flipH="1">
            <a:off x="5178893" y="2481058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5178893" y="260648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5259243" y="2387468"/>
            <a:ext cx="5741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5259243" y="251001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797773" y="25561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797773" y="24123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2619839" y="2101574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9" t="43859" r="23827" b="51524"/>
          <a:stretch/>
        </p:blipFill>
        <p:spPr>
          <a:xfrm>
            <a:off x="3000142" y="2697134"/>
            <a:ext cx="2160000" cy="15835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9" name="Gerade Verbindung mit Pfeil 18"/>
          <p:cNvCxnSpPr/>
          <p:nvPr/>
        </p:nvCxnSpPr>
        <p:spPr>
          <a:xfrm flipH="1">
            <a:off x="5178893" y="2751230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5259243" y="2661065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797773" y="27197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11" t="39796" r="23414" b="55402"/>
          <a:stretch/>
        </p:blipFill>
        <p:spPr>
          <a:xfrm>
            <a:off x="3000142" y="2864470"/>
            <a:ext cx="2160000" cy="16469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3" name="Gerade Verbindung mit Pfeil 22"/>
          <p:cNvCxnSpPr/>
          <p:nvPr/>
        </p:nvCxnSpPr>
        <p:spPr>
          <a:xfrm flipH="1">
            <a:off x="5178893" y="2925730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5259243" y="2834771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797773" y="28749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66" t="37025" r="20657" b="59281"/>
          <a:stretch/>
        </p:blipFill>
        <p:spPr>
          <a:xfrm>
            <a:off x="3000142" y="3030156"/>
            <a:ext cx="2160000" cy="1266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7" name="Gerade Verbindung mit Pfeil 26"/>
          <p:cNvCxnSpPr/>
          <p:nvPr/>
        </p:nvCxnSpPr>
        <p:spPr>
          <a:xfrm flipH="1">
            <a:off x="5178893" y="3064011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feld 27"/>
          <p:cNvSpPr txBox="1"/>
          <p:nvPr/>
        </p:nvSpPr>
        <p:spPr>
          <a:xfrm>
            <a:off x="5259243" y="2974863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2797773" y="30165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8" t="51432" r="23826" b="43582"/>
          <a:stretch/>
        </p:blipFill>
        <p:spPr>
          <a:xfrm>
            <a:off x="3000142" y="3166319"/>
            <a:ext cx="2160000" cy="17102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1" name="Gerade Verbindung mit Pfeil 30"/>
          <p:cNvCxnSpPr/>
          <p:nvPr/>
        </p:nvCxnSpPr>
        <p:spPr>
          <a:xfrm flipH="1">
            <a:off x="5178893" y="3220381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5259243" y="3137633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2797773" y="31606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7" t="37949" r="20516" b="58357"/>
          <a:stretch/>
        </p:blipFill>
        <p:spPr>
          <a:xfrm>
            <a:off x="3000142" y="3336431"/>
            <a:ext cx="2160000" cy="1266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5" name="Gerade Verbindung mit Pfeil 34"/>
          <p:cNvCxnSpPr/>
          <p:nvPr/>
        </p:nvCxnSpPr>
        <p:spPr>
          <a:xfrm flipH="1">
            <a:off x="5178893" y="338871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feld 35"/>
          <p:cNvSpPr txBox="1"/>
          <p:nvPr/>
        </p:nvSpPr>
        <p:spPr>
          <a:xfrm>
            <a:off x="5259243" y="3290063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2797773" y="33114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Gerade Verbindung mit Pfeil 37"/>
          <p:cNvCxnSpPr/>
          <p:nvPr/>
        </p:nvCxnSpPr>
        <p:spPr>
          <a:xfrm flipH="1">
            <a:off x="5178893" y="234662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5259243" y="2253316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2797773" y="22674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5121244" y="1544720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3504071" y="1349441"/>
            <a:ext cx="15160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ADD </a:t>
            </a:r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IPK3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2705578" y="12489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3032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64" t="32592" r="21759" b="64084"/>
          <a:stretch/>
        </p:blipFill>
        <p:spPr>
          <a:xfrm>
            <a:off x="5666727" y="184734"/>
            <a:ext cx="2160000" cy="1140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77" t="31855" r="21346" b="63528"/>
          <a:stretch/>
        </p:blipFill>
        <p:spPr>
          <a:xfrm>
            <a:off x="402938" y="140393"/>
            <a:ext cx="2160000" cy="15835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Gerade Verbindung mit Pfeil 6"/>
          <p:cNvCxnSpPr/>
          <p:nvPr/>
        </p:nvCxnSpPr>
        <p:spPr>
          <a:xfrm flipH="1">
            <a:off x="7845478" y="240280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7925828" y="146690"/>
            <a:ext cx="5741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5464358" y="1715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2581689" y="218148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2662039" y="124839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00569" y="1389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8" t="14124" r="15835" b="21788"/>
          <a:stretch/>
        </p:blipFill>
        <p:spPr>
          <a:xfrm>
            <a:off x="5394190" y="449814"/>
            <a:ext cx="3065929" cy="2666360"/>
          </a:xfrm>
          <a:prstGeom prst="rect">
            <a:avLst/>
          </a:prstGeom>
        </p:spPr>
      </p:pic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8" r="16111" b="22343"/>
          <a:stretch/>
        </p:blipFill>
        <p:spPr>
          <a:xfrm>
            <a:off x="4956201" y="3429000"/>
            <a:ext cx="3941909" cy="3230944"/>
          </a:xfrm>
          <a:prstGeom prst="rect">
            <a:avLst/>
          </a:prstGeom>
        </p:spPr>
      </p:pic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6" t="14124" r="15835" b="22527"/>
          <a:stretch/>
        </p:blipFill>
        <p:spPr>
          <a:xfrm>
            <a:off x="471797" y="522513"/>
            <a:ext cx="3127401" cy="2635624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53" r="15561" b="22158"/>
          <a:stretch/>
        </p:blipFill>
        <p:spPr>
          <a:xfrm>
            <a:off x="471797" y="3507953"/>
            <a:ext cx="4026433" cy="3238628"/>
          </a:xfrm>
          <a:prstGeom prst="rect">
            <a:avLst/>
          </a:prstGeom>
        </p:spPr>
      </p:pic>
      <p:sp>
        <p:nvSpPr>
          <p:cNvPr id="40" name="Rechteck 39"/>
          <p:cNvSpPr/>
          <p:nvPr/>
        </p:nvSpPr>
        <p:spPr>
          <a:xfrm>
            <a:off x="699690" y="385163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699690" y="46387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699690" y="47261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699690" y="48175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699690" y="49181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699690" y="51033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699690" y="53157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699690" y="56799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699690" y="58868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699690" y="61506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699690" y="63983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699690" y="44787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1390175" y="440642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3" name="Rechteck 52"/>
          <p:cNvSpPr/>
          <p:nvPr/>
        </p:nvSpPr>
        <p:spPr>
          <a:xfrm>
            <a:off x="619174" y="1205632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4" name="Rechteck 53"/>
          <p:cNvSpPr/>
          <p:nvPr/>
        </p:nvSpPr>
        <p:spPr>
          <a:xfrm>
            <a:off x="5188715" y="372083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188715" y="45079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188715" y="45953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188715" y="46867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188715" y="47873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188715" y="49725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188715" y="51849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188715" y="55491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188715" y="57560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188715" y="60197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188715" y="62675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188715" y="43479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5879200" y="427562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7" name="Rechteck 66"/>
          <p:cNvSpPr/>
          <p:nvPr/>
        </p:nvSpPr>
        <p:spPr>
          <a:xfrm>
            <a:off x="5510831" y="1132955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61245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60" t="46630" r="23965" b="49492"/>
          <a:stretch/>
        </p:blipFill>
        <p:spPr>
          <a:xfrm>
            <a:off x="548936" y="170571"/>
            <a:ext cx="2160000" cy="13302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" name="Gerade Verbindung mit Pfeil 2"/>
          <p:cNvCxnSpPr/>
          <p:nvPr/>
        </p:nvCxnSpPr>
        <p:spPr>
          <a:xfrm flipH="1">
            <a:off x="2727687" y="22443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2808037" y="12796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346567" y="1740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9" t="43859" r="23827" b="51524"/>
          <a:stretch/>
        </p:blipFill>
        <p:spPr>
          <a:xfrm>
            <a:off x="5666727" y="105541"/>
            <a:ext cx="2160000" cy="15835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Gerade Verbindung mit Pfeil 6"/>
          <p:cNvCxnSpPr/>
          <p:nvPr/>
        </p:nvCxnSpPr>
        <p:spPr>
          <a:xfrm flipH="1">
            <a:off x="7845478" y="15963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>
            <a:off x="7925828" y="69472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464358" y="1281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54" t="10246" r="17626" b="11077"/>
          <a:stretch/>
        </p:blipFill>
        <p:spPr>
          <a:xfrm>
            <a:off x="346567" y="3360015"/>
            <a:ext cx="3911173" cy="3273398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79" t="23359" r="18178" b="10153"/>
          <a:stretch/>
        </p:blipFill>
        <p:spPr>
          <a:xfrm>
            <a:off x="346567" y="409098"/>
            <a:ext cx="3142770" cy="2766252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32" t="28715" r="17075" b="16248"/>
          <a:stretch/>
        </p:blipFill>
        <p:spPr>
          <a:xfrm>
            <a:off x="5190710" y="507146"/>
            <a:ext cx="3112034" cy="2289842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57" t="10984" r="17074" b="10708"/>
          <a:stretch/>
        </p:blipFill>
        <p:spPr>
          <a:xfrm>
            <a:off x="4916996" y="3429000"/>
            <a:ext cx="3880437" cy="3258030"/>
          </a:xfrm>
          <a:prstGeom prst="rect">
            <a:avLst/>
          </a:prstGeom>
        </p:spPr>
      </p:pic>
      <p:sp>
        <p:nvSpPr>
          <p:cNvPr id="30" name="Rechteck 29"/>
          <p:cNvSpPr/>
          <p:nvPr/>
        </p:nvSpPr>
        <p:spPr>
          <a:xfrm>
            <a:off x="438125" y="366933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438125" y="44564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438125" y="45438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438125" y="46352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438125" y="47358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438125" y="49210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438125" y="5133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438125" y="54976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438125" y="57045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438125" y="59682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438125" y="62160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438125" y="42964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1128610" y="422412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3" name="Rechteck 42"/>
          <p:cNvSpPr/>
          <p:nvPr/>
        </p:nvSpPr>
        <p:spPr>
          <a:xfrm>
            <a:off x="501629" y="1342357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4" name="Rechteck 43"/>
          <p:cNvSpPr/>
          <p:nvPr/>
        </p:nvSpPr>
        <p:spPr>
          <a:xfrm>
            <a:off x="5039783" y="372312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039783" y="45102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039783" y="45976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039783" y="46890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039783" y="47896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039783" y="49748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039783" y="51872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039783" y="55514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039783" y="57583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039783" y="60220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039783" y="62698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039783" y="43502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730268" y="427791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7" name="Rechteck 56"/>
          <p:cNvSpPr/>
          <p:nvPr/>
        </p:nvSpPr>
        <p:spPr>
          <a:xfrm>
            <a:off x="5330404" y="1159395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72600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11" t="39796" r="23414" b="55402"/>
          <a:stretch/>
        </p:blipFill>
        <p:spPr>
          <a:xfrm>
            <a:off x="402416" y="182743"/>
            <a:ext cx="2160000" cy="16469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" name="Gerade Verbindung mit Pfeil 2"/>
          <p:cNvCxnSpPr/>
          <p:nvPr/>
        </p:nvCxnSpPr>
        <p:spPr>
          <a:xfrm flipH="1">
            <a:off x="2581167" y="244003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2661517" y="153044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0047" y="1932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66" t="37025" r="20657" b="59281"/>
          <a:stretch/>
        </p:blipFill>
        <p:spPr>
          <a:xfrm>
            <a:off x="5856272" y="129872"/>
            <a:ext cx="2160000" cy="1266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Gerade Verbindung mit Pfeil 6"/>
          <p:cNvCxnSpPr/>
          <p:nvPr/>
        </p:nvCxnSpPr>
        <p:spPr>
          <a:xfrm flipH="1">
            <a:off x="8035023" y="16372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>
            <a:off x="8115373" y="74579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653903" y="1162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8" t="3412" r="17351" b="17726"/>
          <a:stretch/>
        </p:blipFill>
        <p:spPr>
          <a:xfrm>
            <a:off x="335661" y="3511604"/>
            <a:ext cx="3872753" cy="3281082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18" t="17079" r="17489" b="19203"/>
          <a:stretch/>
        </p:blipFill>
        <p:spPr>
          <a:xfrm>
            <a:off x="335661" y="438395"/>
            <a:ext cx="3112034" cy="2650992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57" t="4705" r="14734" b="21604"/>
          <a:stretch/>
        </p:blipFill>
        <p:spPr>
          <a:xfrm>
            <a:off x="5134366" y="3619180"/>
            <a:ext cx="3603812" cy="3065929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00" t="18187" r="14045" b="29176"/>
          <a:stretch/>
        </p:blipFill>
        <p:spPr>
          <a:xfrm>
            <a:off x="5301983" y="438395"/>
            <a:ext cx="3104350" cy="2189950"/>
          </a:xfrm>
          <a:prstGeom prst="rect">
            <a:avLst/>
          </a:prstGeom>
        </p:spPr>
      </p:pic>
      <p:sp>
        <p:nvSpPr>
          <p:cNvPr id="22" name="Rechteck 21"/>
          <p:cNvSpPr/>
          <p:nvPr/>
        </p:nvSpPr>
        <p:spPr>
          <a:xfrm>
            <a:off x="427940" y="382301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27940" y="46101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427940" y="46975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27940" y="47889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427940" y="48895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27940" y="50747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427940" y="52871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427940" y="56513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427940" y="58582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427940" y="61219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427940" y="63697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427940" y="44500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118425" y="437780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5" name="Rechteck 34"/>
          <p:cNvSpPr/>
          <p:nvPr/>
        </p:nvSpPr>
        <p:spPr>
          <a:xfrm>
            <a:off x="475355" y="1372283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6" name="Rechteck 35"/>
          <p:cNvSpPr/>
          <p:nvPr/>
        </p:nvSpPr>
        <p:spPr>
          <a:xfrm>
            <a:off x="4991178" y="369220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4991178" y="44793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4991178" y="45667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4991178" y="46581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4991178" y="47587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4991178" y="49439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4991178" y="51563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4991178" y="55205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4991178" y="57274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4991178" y="59911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4991178" y="62389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4991178" y="43192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681663" y="424700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9" name="Rechteck 48"/>
          <p:cNvSpPr/>
          <p:nvPr/>
        </p:nvSpPr>
        <p:spPr>
          <a:xfrm>
            <a:off x="5437564" y="1182040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78862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8" t="51432" r="23826" b="43582"/>
          <a:stretch/>
        </p:blipFill>
        <p:spPr>
          <a:xfrm>
            <a:off x="771772" y="215650"/>
            <a:ext cx="2160000" cy="17102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" name="Gerade Verbindung mit Pfeil 2"/>
          <p:cNvCxnSpPr/>
          <p:nvPr/>
        </p:nvCxnSpPr>
        <p:spPr>
          <a:xfrm flipH="1">
            <a:off x="2950523" y="26971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3030873" y="186964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569403" y="2099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7" t="37949" r="20516" b="58357"/>
          <a:stretch/>
        </p:blipFill>
        <p:spPr>
          <a:xfrm>
            <a:off x="5818144" y="226956"/>
            <a:ext cx="2160000" cy="1266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Gerade Verbindung mit Pfeil 6"/>
          <p:cNvCxnSpPr/>
          <p:nvPr/>
        </p:nvCxnSpPr>
        <p:spPr>
          <a:xfrm flipH="1">
            <a:off x="7996895" y="27924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>
            <a:off x="8077245" y="180588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615775" y="2020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29" t="3597" r="17902" b="18465"/>
          <a:stretch/>
        </p:blipFill>
        <p:spPr>
          <a:xfrm>
            <a:off x="192100" y="3465500"/>
            <a:ext cx="3880437" cy="3242662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69" t="20219" r="17489" b="18649"/>
          <a:stretch/>
        </p:blipFill>
        <p:spPr>
          <a:xfrm>
            <a:off x="437989" y="477381"/>
            <a:ext cx="3081298" cy="2543415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25" t="20588" r="14182" b="23636"/>
          <a:stretch/>
        </p:blipFill>
        <p:spPr>
          <a:xfrm>
            <a:off x="5342127" y="867636"/>
            <a:ext cx="3112034" cy="232057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14" r="14320" b="24374"/>
          <a:stretch/>
        </p:blipFill>
        <p:spPr>
          <a:xfrm>
            <a:off x="4733365" y="3561742"/>
            <a:ext cx="4164747" cy="3146420"/>
          </a:xfrm>
          <a:prstGeom prst="rect">
            <a:avLst/>
          </a:prstGeom>
        </p:spPr>
      </p:pic>
      <p:sp>
        <p:nvSpPr>
          <p:cNvPr id="14" name="Rechteck 13"/>
          <p:cNvSpPr/>
          <p:nvPr/>
        </p:nvSpPr>
        <p:spPr>
          <a:xfrm>
            <a:off x="227893" y="378459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227893" y="45717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227893" y="46591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227893" y="47504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227893" y="48511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227893" y="50363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227893" y="52487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227893" y="56129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227893" y="58197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227893" y="60835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227893" y="63312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227893" y="44116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918378" y="433938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7" name="Rechteck 26"/>
          <p:cNvSpPr/>
          <p:nvPr/>
        </p:nvSpPr>
        <p:spPr>
          <a:xfrm>
            <a:off x="514830" y="1745264"/>
            <a:ext cx="271337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/>
          <p:cNvSpPr/>
          <p:nvPr/>
        </p:nvSpPr>
        <p:spPr>
          <a:xfrm>
            <a:off x="5093743" y="375355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093743" y="45406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093743" y="46280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093743" y="47194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093743" y="48201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093743" y="50052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093743" y="52176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093743" y="55818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093743" y="57887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093743" y="60525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093743" y="63002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093743" y="43806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784228" y="430834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1" name="Rechteck 40"/>
          <p:cNvSpPr/>
          <p:nvPr/>
        </p:nvSpPr>
        <p:spPr>
          <a:xfrm>
            <a:off x="5481821" y="1568490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3467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0</Words>
  <Application>Microsoft Office PowerPoint</Application>
  <PresentationFormat>Bildschirmpräsentation (4:3)</PresentationFormat>
  <Paragraphs>195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3</cp:revision>
  <dcterms:created xsi:type="dcterms:W3CDTF">2024-10-21T12:55:10Z</dcterms:created>
  <dcterms:modified xsi:type="dcterms:W3CDTF">2024-10-21T13:15:28Z</dcterms:modified>
</cp:coreProperties>
</file>